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799763" cy="10799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DCD1D7-77F0-4DFC-9412-A8C63A1E6D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97218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280" y="6243840"/>
            <a:ext cx="97218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2911AF-4D9C-492B-B93C-911089FC5A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2096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280" y="624384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20960" y="624384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DA7E9-206F-4559-91DC-2092850248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26440" y="252072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13600" y="252072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280" y="624384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26440" y="624384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13600" y="6243840"/>
            <a:ext cx="31302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14B2D-43E8-4D39-B367-48A84FE223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280" y="2520720"/>
            <a:ext cx="9721800" cy="712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B39B7-D9A5-4781-92A8-675F85971E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972180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C1384-B728-4E59-B7B8-3C9ED1BE65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474408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20960" y="2520720"/>
            <a:ext cx="474408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E1576-7853-419C-820B-34D5C333FE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6EDE0-2FB6-478E-A29F-6CE422C39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280" y="431280"/>
            <a:ext cx="9721800" cy="834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01"/>
              </a:spcBef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90DB9-8004-44F4-A3BE-D6108D0A51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20960" y="2520720"/>
            <a:ext cx="474408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280" y="624384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8A49A7-DF4B-4B90-87FE-2D8EF67951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474408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2096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20960" y="624384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E25CC-D657-46A9-BD6A-16A77F952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28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20960" y="2520720"/>
            <a:ext cx="474408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280" y="6243840"/>
            <a:ext cx="9721800" cy="33998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772D0-5ECC-4C6B-8569-EFD30E88C8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280" y="431280"/>
            <a:ext cx="9721800" cy="18003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ctr">
            <a:noAutofit/>
          </a:bodyPr>
          <a:p>
            <a:pPr indent="0" algn="ctr">
              <a:buNone/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280" y="2520720"/>
            <a:ext cx="9721800" cy="712764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rmAutofit/>
          </a:bodyPr>
          <a:p>
            <a:pPr marL="423720" indent="-423720"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1" marL="919080" indent="-353880">
              <a:spcBef>
                <a:spcPts val="1001"/>
              </a:spcBef>
              <a:buClr>
                <a:srgbClr val="000000"/>
              </a:buClr>
              <a:buFont typeface="Arial"/>
              <a:buChar char="–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2" marL="1414440" indent="-282600"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3" marL="1979640" indent="-282600">
              <a:spcBef>
                <a:spcPts val="1001"/>
              </a:spcBef>
              <a:buClr>
                <a:srgbClr val="000000"/>
              </a:buClr>
              <a:buFont typeface="Arial"/>
              <a:buChar char="–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4" marL="2546280" indent="-28260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5" marL="2546280" indent="-28260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6" marL="2546280" indent="-28260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9835920"/>
            <a:ext cx="2521080" cy="7491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91080" y="9835920"/>
            <a:ext cx="3419280" cy="7491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40720" y="9835920"/>
            <a:ext cx="2520720" cy="749160"/>
          </a:xfrm>
          <a:prstGeom prst="rect">
            <a:avLst/>
          </a:prstGeom>
          <a:noFill/>
          <a:ln w="0">
            <a:noFill/>
          </a:ln>
        </p:spPr>
        <p:txBody>
          <a:bodyPr lIns="113040" rIns="113040" tIns="56520" bIns="565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C5D8EF-15DF-4785-ACF4-B1544F822DDF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3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4.png"/><Relationship Id="rId9" Type="http://schemas.openxmlformats.org/officeDocument/2006/relationships/package" Target="../embeddings/oleObject5.xlsx"/><Relationship Id="rId10" Type="http://schemas.openxmlformats.org/officeDocument/2006/relationships/image" Target="../media/image5.png"/><Relationship Id="rId11" Type="http://schemas.openxmlformats.org/officeDocument/2006/relationships/package" Target="../embeddings/oleObject6.xlsx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32"/>
          <p:cNvGraphicFramePr/>
          <p:nvPr/>
        </p:nvGraphicFramePr>
        <p:xfrm>
          <a:off x="142920" y="480960"/>
          <a:ext cx="3505320" cy="33195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3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2920" y="480960"/>
                    <a:ext cx="3505320" cy="331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34"/>
          <p:cNvGraphicFramePr/>
          <p:nvPr/>
        </p:nvGraphicFramePr>
        <p:xfrm>
          <a:off x="3495600" y="600120"/>
          <a:ext cx="3810240" cy="32004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Object 3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95600" y="600120"/>
                    <a:ext cx="3810240" cy="320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35"/>
          <p:cNvGraphicFramePr/>
          <p:nvPr/>
        </p:nvGraphicFramePr>
        <p:xfrm>
          <a:off x="219240" y="3952800"/>
          <a:ext cx="3288960" cy="331632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Object 3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19240" y="3952800"/>
                    <a:ext cx="3288960" cy="3316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33"/>
          <p:cNvGraphicFramePr/>
          <p:nvPr/>
        </p:nvGraphicFramePr>
        <p:xfrm>
          <a:off x="7077240" y="482760"/>
          <a:ext cx="3608280" cy="331776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Object 3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077240" y="482760"/>
                    <a:ext cx="3608280" cy="3317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38"/>
          <p:cNvGraphicFramePr/>
          <p:nvPr/>
        </p:nvGraphicFramePr>
        <p:xfrm>
          <a:off x="3419640" y="3876840"/>
          <a:ext cx="3733560" cy="335268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50" name="Object 3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419640" y="3876840"/>
                    <a:ext cx="3733560" cy="335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39"/>
          <p:cNvGraphicFramePr/>
          <p:nvPr/>
        </p:nvGraphicFramePr>
        <p:xfrm>
          <a:off x="7077240" y="3952800"/>
          <a:ext cx="3581280" cy="320040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52" name="Object 3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7077240" y="3952800"/>
                    <a:ext cx="3581280" cy="320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Rectangle 40"/>
          <p:cNvSpPr/>
          <p:nvPr/>
        </p:nvSpPr>
        <p:spPr>
          <a:xfrm>
            <a:off x="219240" y="7229520"/>
            <a:ext cx="103629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ivity of ROS scavenging enzymes and antioxidants contents in seedlings of the two rice genotypes subjected to cold stress. ROS scavenging enzymes: (A) CAT activity, (B) POD activity, (C) SOD activity and (D) GR activity; antioxidants: (E) ascorbate, (F) GSH. LTH cultivar (white) and IR29 cultivar (black). Values are means of 3 replicates. Vertical bars indicate standard erro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2"/>
          <p:cNvSpPr/>
          <p:nvPr/>
        </p:nvSpPr>
        <p:spPr>
          <a:xfrm>
            <a:off x="982800" y="523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3"/>
          <p:cNvSpPr/>
          <p:nvPr/>
        </p:nvSpPr>
        <p:spPr>
          <a:xfrm>
            <a:off x="7840440" y="40291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4"/>
          <p:cNvSpPr/>
          <p:nvPr/>
        </p:nvSpPr>
        <p:spPr>
          <a:xfrm>
            <a:off x="4106880" y="4043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5"/>
          <p:cNvSpPr/>
          <p:nvPr/>
        </p:nvSpPr>
        <p:spPr>
          <a:xfrm>
            <a:off x="906840" y="4029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6"/>
          <p:cNvSpPr/>
          <p:nvPr/>
        </p:nvSpPr>
        <p:spPr>
          <a:xfrm>
            <a:off x="7917120" y="523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7"/>
          <p:cNvSpPr/>
          <p:nvPr/>
        </p:nvSpPr>
        <p:spPr>
          <a:xfrm>
            <a:off x="4335480" y="523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131840"/>
                <a:tab algn="l" pos="2263680"/>
                <a:tab algn="l" pos="3395520"/>
                <a:tab algn="l" pos="4527720"/>
                <a:tab algn="l" pos="5659560"/>
                <a:tab algn="l" pos="6791400"/>
                <a:tab algn="l" pos="7923240"/>
                <a:tab algn="l" pos="9055080"/>
                <a:tab algn="l" pos="101869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tingwing</cp:lastModifiedBy>
  <dcterms:modified xsi:type="dcterms:W3CDTF">2012-07-23T08:20:05Z</dcterms:modified>
  <cp:revision>1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